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3BB6C4-7FB0-4BFE-8296-E1FCA1F2EE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BF5DA-497E-4C95-BD91-7980ED53A3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1010D-0640-48BE-BD0E-F5E14AE593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62046-B9AB-4E25-897E-5186DC387B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50EFA5-B3F4-4A44-8309-1DE94A2A0D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4A85E-C516-4FB4-B682-D8F22A853A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372C5-6565-4156-9D51-58467A3B9A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5B739-04C0-4B00-9A8B-BD234B23D3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1F850-778F-4DA5-B464-4AB5833A9F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F4936C-BE2D-444C-AAF9-1C6A3FD7F2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45C22-8C7E-4E69-9FD4-76D520EE12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06F29-6B5D-4F64-8EA3-658A5DC0ED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8533E6-04E2-46FC-903C-877BCA0EC97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1081080" y="1843200"/>
            <a:ext cx="4208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3. Pairwise T-tests on principle components, genotypes grouped by Structure cluster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2"/>
          <p:cNvSpPr/>
          <p:nvPr/>
        </p:nvSpPr>
        <p:spPr>
          <a:xfrm>
            <a:off x="1193760" y="6229440"/>
            <a:ext cx="4111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vels not connected by same letter are significantly different. p &lt; 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173240" y="2265480"/>
          <a:ext cx="3981240" cy="3944880"/>
        </p:xfrm>
        <a:graphic>
          <a:graphicData uri="http://schemas.openxmlformats.org/drawingml/2006/table">
            <a:tbl>
              <a:tblPr/>
              <a:tblGrid>
                <a:gridCol w="884160"/>
                <a:gridCol w="1089000"/>
                <a:gridCol w="228600"/>
                <a:gridCol w="228600"/>
                <a:gridCol w="228600"/>
                <a:gridCol w="228600"/>
                <a:gridCol w="228600"/>
                <a:gridCol w="228600"/>
                <a:gridCol w="636480"/>
              </a:tblGrid>
              <a:tr h="371520"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rinciple Compon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lust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6"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evel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S Mea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 rowSpan="6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n-Pungen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0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0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ddMix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5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ahei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0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xican ho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68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44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apanese/Korea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.06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0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mall Ho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.57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 rowSpan="6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mall Ho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3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44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apanese/Korea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09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ddMix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1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0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nPu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4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ahei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13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xican ho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21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 rowSpan="6"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>
                      <a:noFill/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mHo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19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on-Pungen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B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32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ddMix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ahei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6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458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Japanese/Korea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.39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90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exican ho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120" rIns="6120" tIns="61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2.78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6120" marR="6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3T04:24:02Z</dcterms:created>
  <dc:creator>Theresa Hill</dc:creator>
  <dc:description/>
  <dc:language>en-US</dc:language>
  <cp:lastModifiedBy>Theresa Hill</cp:lastModifiedBy>
  <dcterms:modified xsi:type="dcterms:W3CDTF">2012-09-07T07:32:38Z</dcterms:modified>
  <cp:revision>3</cp:revision>
  <dc:subject/>
  <dc:title>PowerPoint Presentation</dc:title>
</cp:coreProperties>
</file>